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8" userDrawn="1">
          <p15:clr>
            <a:srgbClr val="A4A3A4"/>
          </p15:clr>
        </p15:guide>
        <p15:guide id="2" pos="8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53" d="100"/>
          <a:sy n="53" d="100"/>
        </p:scale>
        <p:origin x="1812" y="36"/>
      </p:cViewPr>
      <p:guideLst>
        <p:guide orient="horz" pos="3118"/>
        <p:guide pos="8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0506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9315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186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1563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5886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929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2275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942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7823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6966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02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3F5D80-EDF2-471C-979E-CCF277EB0D28}" type="datetimeFigureOut">
              <a:rPr lang="en-GB" smtClean="0"/>
              <a:t>16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27E12C-3B81-49AE-9FDC-7D57D6A9A13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1345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7.xml"/><Relationship Id="rId1" Type="http://schemas.openxmlformats.org/officeDocument/2006/relationships/themeOverride" Target="../theme/themeOverr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C9E31B85-3428-4CE4-82D2-6319DC0F37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1087" y="2711731"/>
            <a:ext cx="6268225" cy="6650750"/>
          </a:xfrm>
          <a:prstGeom prst="rect">
            <a:avLst/>
          </a:prstGeom>
          <a:noFill/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E75F5446-4C38-4B60-ABD6-1D60121B2D2D}"/>
              </a:ext>
            </a:extLst>
          </p:cNvPr>
          <p:cNvSpPr txBox="1"/>
          <p:nvPr/>
        </p:nvSpPr>
        <p:spPr>
          <a:xfrm>
            <a:off x="518400" y="475200"/>
            <a:ext cx="62136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ile 3: Figure S3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upal weight. Dry weight [DW, mg, mean ± 95% CI] of female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e. </a:t>
            </a:r>
            <a:r>
              <a:rPr lang="en-US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bopictu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x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ipiens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pure and mixed cohort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pendence of temperature and larval food regime. Line - linear regression. Dotted lines - 95% confidence interval.</a:t>
            </a:r>
            <a:endParaRPr lang="en-GB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950514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9</Words>
  <Application>Microsoft Office PowerPoint</Application>
  <PresentationFormat>Benutzerdefiniert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uth</dc:creator>
  <cp:lastModifiedBy>Ruth</cp:lastModifiedBy>
  <cp:revision>2</cp:revision>
  <dcterms:created xsi:type="dcterms:W3CDTF">2018-01-16T15:29:56Z</dcterms:created>
  <dcterms:modified xsi:type="dcterms:W3CDTF">2018-01-16T15:37:54Z</dcterms:modified>
</cp:coreProperties>
</file>